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00" r:id="rId2"/>
  </p:sldIdLst>
  <p:sldSz cx="9601200" cy="12801600" type="A3"/>
  <p:notesSz cx="6858000" cy="9144000"/>
  <p:defaultTextStyle>
    <a:defPPr>
      <a:defRPr lang="en-US"/>
    </a:defPPr>
    <a:lvl1pPr marL="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21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CEBEB"/>
    <a:srgbClr val="FEFF1C"/>
    <a:srgbClr val="FF9700"/>
    <a:srgbClr val="FFB502"/>
    <a:srgbClr val="FF0100"/>
    <a:srgbClr val="FFD302"/>
    <a:srgbClr val="FCB301"/>
    <a:srgbClr val="F69102"/>
    <a:srgbClr val="FFFF1B"/>
    <a:srgbClr val="F054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90"/>
    <p:restoredTop sz="95073"/>
  </p:normalViewPr>
  <p:slideViewPr>
    <p:cSldViewPr snapToGrid="0" snapToObjects="1">
      <p:cViewPr varScale="1">
        <p:scale>
          <a:sx n="57" d="100"/>
          <a:sy n="57" d="100"/>
        </p:scale>
        <p:origin x="3096" y="192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2015%20mandarin%20ethylene%20exp/ethylene%20&#24188;&#26524;&#6537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4444444444444441E-2"/>
          <c:y val="2.4259259259259258E-2"/>
          <c:w val="0.90328242975365969"/>
          <c:h val="0.90202721048203038"/>
        </c:manualLayout>
      </c:layout>
      <c:lineChart>
        <c:grouping val="standard"/>
        <c:varyColors val="0"/>
        <c:ser>
          <c:idx val="0"/>
          <c:order val="0"/>
          <c:tx>
            <c:strRef>
              <c:f>harvest8!$W$98</c:f>
              <c:strCache>
                <c:ptCount val="1"/>
                <c:pt idx="0">
                  <c:v>Control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</c:marker>
          <c:cat>
            <c:numRef>
              <c:f>harvest8!$X$97:$AB$97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</c:numCache>
            </c:numRef>
          </c:cat>
          <c:val>
            <c:numRef>
              <c:f>harvest8!$X$98:$AB$98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C43-674C-8482-3444A42897E9}"/>
            </c:ext>
          </c:extLst>
        </c:ser>
        <c:ser>
          <c:idx val="1"/>
          <c:order val="1"/>
          <c:tx>
            <c:strRef>
              <c:f>harvest8!$W$99</c:f>
              <c:strCache>
                <c:ptCount val="1"/>
                <c:pt idx="0">
                  <c:v>1-MCP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10"/>
            <c:spPr>
              <a:solidFill>
                <a:schemeClr val="bg1"/>
              </a:solidFill>
              <a:ln w="1905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harvest8!$X$103:$AB$10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172967392710298E-2</c:v>
                  </c:pt>
                  <c:pt idx="2">
                    <c:v>0.62437331631721493</c:v>
                  </c:pt>
                  <c:pt idx="3">
                    <c:v>0.71822507273964153</c:v>
                  </c:pt>
                  <c:pt idx="4">
                    <c:v>0.19754624042339106</c:v>
                  </c:pt>
                </c:numCache>
              </c:numRef>
            </c:plus>
            <c:minus>
              <c:numRef>
                <c:f>harvest8!$X$103:$AB$10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172967392710298E-2</c:v>
                  </c:pt>
                  <c:pt idx="2">
                    <c:v>0.62437331631721493</c:v>
                  </c:pt>
                  <c:pt idx="3">
                    <c:v>0.71822507273964153</c:v>
                  </c:pt>
                  <c:pt idx="4">
                    <c:v>0.1975462404233910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harvest8!$X$97:$AB$97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</c:numCache>
            </c:numRef>
          </c:cat>
          <c:val>
            <c:numRef>
              <c:f>harvest8!$X$99:$AB$99</c:f>
              <c:numCache>
                <c:formatCode>0.00</c:formatCode>
                <c:ptCount val="5"/>
                <c:pt idx="0" formatCode="General">
                  <c:v>0</c:v>
                </c:pt>
                <c:pt idx="1">
                  <c:v>7.3626588836776738E-3</c:v>
                </c:pt>
                <c:pt idx="2">
                  <c:v>1.713996484579948</c:v>
                </c:pt>
                <c:pt idx="3">
                  <c:v>2.2957761881205521</c:v>
                </c:pt>
                <c:pt idx="4">
                  <c:v>1.35702307199642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C43-674C-8482-3444A42897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45443439"/>
        <c:axId val="1545055487"/>
      </c:lineChart>
      <c:catAx>
        <c:axId val="15454434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defRPr>
            </a:pPr>
            <a:endParaRPr lang="en-JP"/>
          </a:p>
        </c:txPr>
        <c:crossAx val="1545055487"/>
        <c:crosses val="autoZero"/>
        <c:auto val="1"/>
        <c:lblAlgn val="ctr"/>
        <c:lblOffset val="100"/>
        <c:noMultiLvlLbl val="0"/>
      </c:catAx>
      <c:valAx>
        <c:axId val="1545055487"/>
        <c:scaling>
          <c:orientation val="minMax"/>
          <c:max val="3.5"/>
          <c:min val="0"/>
        </c:scaling>
        <c:delete val="0"/>
        <c:axPos val="l"/>
        <c:numFmt formatCode="#,##0.0" sourceLinked="0"/>
        <c:majorTickMark val="out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defRPr>
            </a:pPr>
            <a:endParaRPr lang="en-JP"/>
          </a:p>
        </c:txPr>
        <c:crossAx val="1545443439"/>
        <c:crosses val="autoZero"/>
        <c:crossBetween val="between"/>
        <c:majorUnit val="0.5"/>
      </c:valAx>
      <c:spPr>
        <a:noFill/>
        <a:ln w="19050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10332174103237095"/>
          <c:y val="0.29455927384076991"/>
          <c:w val="0.27861163919429549"/>
          <c:h val="0.159144429862933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Helvetica Neue" panose="02000503000000020004" pitchFamily="2" charset="0"/>
              <a:ea typeface="Helvetica Neue" panose="02000503000000020004" pitchFamily="2" charset="0"/>
              <a:cs typeface="Helvetica Neue" panose="02000503000000020004" pitchFamily="2" charset="0"/>
            </a:defRPr>
          </a:pPr>
          <a:endParaRPr lang="en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Helvetica Neue" panose="02000503000000020004" pitchFamily="2" charset="0"/>
          <a:ea typeface="Helvetica Neue" panose="02000503000000020004" pitchFamily="2" charset="0"/>
          <a:cs typeface="Helvetica Neue" panose="02000503000000020004" pitchFamily="2" charset="0"/>
        </a:defRPr>
      </a:pPr>
      <a:endParaRPr lang="en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82A022-C9F4-0148-975C-F94539B6FB3D}" type="datetimeFigureOut">
              <a:rPr lang="en-US" smtClean="0"/>
              <a:t>5/20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5F2F5C-3AD8-114A-9235-54C4AB861D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931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56F7-2C12-5140-B74C-9CF7B726B924}" type="datetimeFigureOut">
              <a:rPr lang="en-US" smtClean="0"/>
              <a:t>5/20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2054F-6DCE-464D-91FB-E2AEAD76D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473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4527769E-95C8-E441-802A-EE43EE2B62E6}"/>
              </a:ext>
            </a:extLst>
          </p:cNvPr>
          <p:cNvGrpSpPr/>
          <p:nvPr/>
        </p:nvGrpSpPr>
        <p:grpSpPr>
          <a:xfrm>
            <a:off x="1698710" y="1344106"/>
            <a:ext cx="5709993" cy="6413118"/>
            <a:chOff x="1698710" y="1344106"/>
            <a:chExt cx="5709993" cy="6413118"/>
          </a:xfrm>
        </p:grpSpPr>
        <p:pic>
          <p:nvPicPr>
            <p:cNvPr id="2" name="Picture 2">
              <a:extLst>
                <a:ext uri="{FF2B5EF4-FFF2-40B4-BE49-F238E27FC236}">
                  <a16:creationId xmlns:a16="http://schemas.microsoft.com/office/drawing/2014/main" id="{88A98C9A-B0CB-A743-8D59-FF40F1A2049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48567" t="12166" b="60103"/>
            <a:stretch/>
          </p:blipFill>
          <p:spPr bwMode="auto">
            <a:xfrm>
              <a:off x="2543176" y="1713438"/>
              <a:ext cx="2049385" cy="8103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830AF38-693E-7D45-8528-E69F3C214F1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/>
            <a:srcRect l="48567" t="47769" b="24499"/>
            <a:stretch/>
          </p:blipFill>
          <p:spPr bwMode="auto">
            <a:xfrm>
              <a:off x="4614862" y="1713439"/>
              <a:ext cx="2049386" cy="8103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83772973-E5C3-564D-91BC-A8F30293FA9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42480784"/>
                </p:ext>
              </p:extLst>
            </p:nvPr>
          </p:nvGraphicFramePr>
          <p:xfrm>
            <a:off x="2386014" y="2709491"/>
            <a:ext cx="4335386" cy="35341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E66E8BE-01A8-CC43-98B4-687719C7F20E}"/>
                </a:ext>
              </a:extLst>
            </p:cNvPr>
            <p:cNvSpPr txBox="1"/>
            <p:nvPr/>
          </p:nvSpPr>
          <p:spPr>
            <a:xfrm>
              <a:off x="2804160" y="1344106"/>
              <a:ext cx="1524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Control (7 d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622019C-2CA6-7348-A282-F5ED267A78A1}"/>
                </a:ext>
              </a:extLst>
            </p:cNvPr>
            <p:cNvSpPr txBox="1"/>
            <p:nvPr/>
          </p:nvSpPr>
          <p:spPr>
            <a:xfrm>
              <a:off x="4953243" y="1344106"/>
              <a:ext cx="14665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1-MCP (7 d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66E6C51-2943-FD49-82A7-55213AC9BD9F}"/>
                </a:ext>
              </a:extLst>
            </p:cNvPr>
            <p:cNvSpPr txBox="1"/>
            <p:nvPr/>
          </p:nvSpPr>
          <p:spPr>
            <a:xfrm>
              <a:off x="3567867" y="6187563"/>
              <a:ext cx="22590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Days after harvest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0B60E58-CF64-9349-800E-3EEC1924C417}"/>
                </a:ext>
              </a:extLst>
            </p:cNvPr>
            <p:cNvSpPr txBox="1"/>
            <p:nvPr/>
          </p:nvSpPr>
          <p:spPr>
            <a:xfrm rot="16200000">
              <a:off x="179721" y="4212525"/>
              <a:ext cx="392150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8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Ethylene production rate (µg kg</a:t>
              </a:r>
              <a:r>
                <a:rPr lang="en-GB" sz="1800" baseline="300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-1</a:t>
              </a:r>
              <a:r>
                <a:rPr lang="en-GB" sz="18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 s</a:t>
              </a:r>
              <a:r>
                <a:rPr lang="en-GB" sz="1800" baseline="300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-1</a:t>
              </a:r>
              <a:r>
                <a:rPr lang="en-GB" sz="18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B812D66-214C-DB40-83B5-0FD180B2039F}"/>
                </a:ext>
              </a:extLst>
            </p:cNvPr>
            <p:cNvSpPr txBox="1"/>
            <p:nvPr/>
          </p:nvSpPr>
          <p:spPr>
            <a:xfrm>
              <a:off x="1698710" y="6556895"/>
              <a:ext cx="5709993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.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 with 1-MCP induced a spike in endogenous ethylene production and rapid senescence in satsuma mandarin fruit. </a:t>
              </a:r>
              <a:r>
                <a:rPr lang="en-GB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Fruit at 145 DAFB with green peel were treated with 2 µLL-1 1-MCP, which was released by adding water to 1- MCP powder (</a:t>
              </a:r>
              <a:r>
                <a:rPr lang="en-GB" sz="1200" dirty="0" err="1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SmartFreshTM</a:t>
              </a:r>
              <a:r>
                <a:rPr lang="en-GB" sz="1200" dirty="0">
                  <a:highlight>
                    <a:srgbClr val="FFFF00"/>
                  </a:highlight>
                  <a:latin typeface="Times New Roman" panose="02020603050405020304" pitchFamily="18" charset="0"/>
                  <a:cs typeface="Times New Roman" panose="02020603050405020304" pitchFamily="18" charset="0"/>
                </a:rPr>
                <a:t>, Rohm and Hass, Philadelphia, PA, USA).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points represent the mean (± SE) of five fruit and different letters indicate significant differences in ANOVA (Tukey’s test, p &lt; 0.05).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E083D1D-C363-0042-906F-079C0CFCCE6A}"/>
                </a:ext>
              </a:extLst>
            </p:cNvPr>
            <p:cNvSpPr txBox="1"/>
            <p:nvPr/>
          </p:nvSpPr>
          <p:spPr>
            <a:xfrm>
              <a:off x="5339140" y="3046673"/>
              <a:ext cx="32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a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DCCC13C-4167-1649-99E9-295DDBFB8FE5}"/>
                </a:ext>
              </a:extLst>
            </p:cNvPr>
            <p:cNvSpPr txBox="1"/>
            <p:nvPr/>
          </p:nvSpPr>
          <p:spPr>
            <a:xfrm>
              <a:off x="6112506" y="4359903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9980DD5-05E4-2D49-9F3B-217FCF859FD3}"/>
                </a:ext>
              </a:extLst>
            </p:cNvPr>
            <p:cNvSpPr txBox="1"/>
            <p:nvPr/>
          </p:nvSpPr>
          <p:spPr>
            <a:xfrm>
              <a:off x="4553706" y="3665220"/>
              <a:ext cx="324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ab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B7C4BA8-01F0-BA4B-94EF-BB926D187282}"/>
                </a:ext>
              </a:extLst>
            </p:cNvPr>
            <p:cNvSpPr txBox="1"/>
            <p:nvPr/>
          </p:nvSpPr>
          <p:spPr>
            <a:xfrm>
              <a:off x="3716819" y="568878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c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04825D0-49EB-904F-BB7A-69E635095ECA}"/>
                </a:ext>
              </a:extLst>
            </p:cNvPr>
            <p:cNvSpPr txBox="1"/>
            <p:nvPr/>
          </p:nvSpPr>
          <p:spPr>
            <a:xfrm>
              <a:off x="2967913" y="568878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c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9409F36-070E-7C4D-A2AB-ACDA102B262D}"/>
                </a:ext>
              </a:extLst>
            </p:cNvPr>
            <p:cNvSpPr txBox="1"/>
            <p:nvPr/>
          </p:nvSpPr>
          <p:spPr>
            <a:xfrm>
              <a:off x="4533381" y="5691695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c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EB1392E-543E-9340-B26E-EC547648C7CF}"/>
                </a:ext>
              </a:extLst>
            </p:cNvPr>
            <p:cNvSpPr txBox="1"/>
            <p:nvPr/>
          </p:nvSpPr>
          <p:spPr>
            <a:xfrm>
              <a:off x="6073399" y="568878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c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1A203F5-9919-324A-8A60-489F75D84F65}"/>
                </a:ext>
              </a:extLst>
            </p:cNvPr>
            <p:cNvSpPr txBox="1"/>
            <p:nvPr/>
          </p:nvSpPr>
          <p:spPr>
            <a:xfrm>
              <a:off x="5311010" y="5688786"/>
              <a:ext cx="32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Helvetica Neue" panose="02000503000000020004" pitchFamily="2" charset="0"/>
                  <a:ea typeface="Helvetica Neue" panose="02000503000000020004" pitchFamily="2" charset="0"/>
                  <a:cs typeface="Helvetica Neue" panose="02000503000000020004" pitchFamily="2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43548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786</TotalTime>
  <Words>115</Words>
  <Application>Microsoft Macintosh PowerPoint</Application>
  <PresentationFormat>A3 Paper (297x420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 Neue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TALO Oscar　Witere</dc:creator>
  <cp:keywords/>
  <dc:description/>
  <cp:lastModifiedBy>Oscar Witere Mitalo</cp:lastModifiedBy>
  <cp:revision>1498</cp:revision>
  <cp:lastPrinted>2022-02-28T04:45:31Z</cp:lastPrinted>
  <dcterms:created xsi:type="dcterms:W3CDTF">2018-04-12T04:09:11Z</dcterms:created>
  <dcterms:modified xsi:type="dcterms:W3CDTF">2022-05-20T02:35:11Z</dcterms:modified>
  <cp:category/>
</cp:coreProperties>
</file>